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8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249BFF1-F97C-D444-F357-F10A9B8035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4A379FF-CEFB-0751-E9FA-D36B07CC67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8E24536-1E3F-0F7F-905A-364E2413E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658E0A0-02B2-D712-9AD7-E9473239E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EA5F71D-B925-AF85-11A1-BC583CA41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2251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04050B-D84D-F74B-6CED-E673E544C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7DD4AED-1D63-F0CC-BE78-68D0D570E5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F9020AA-DD42-BEDF-53FD-A327E5FE9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197A6E4-42CD-3EB8-00C0-0B4D691BF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CDEB15F-9408-C15C-305A-ADE4B0F85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7859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39F7FB7-0DBE-4167-EA0D-B066E28FD7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044E868-E890-52A9-0257-A4BE2B0E3E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59D33BF-8E24-85EA-86C8-4E6809340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1B6B439-1171-7BB2-8C95-67062FCAA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7C07E5C-F09B-F88B-950A-40CD5B43B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52121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357424-6D1E-32CC-440C-04B6D3E13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E995934-8D2E-1068-7322-1DA9B867BC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1AAA0CE-028B-AA7B-E9D5-4CBAD55DB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B8D9958-7A13-2756-8998-46B048A17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2C1B648-6E08-A14E-C73D-7736653F8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9809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F6EE473-83EB-C05E-62F1-E7AC52FEB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21E77A8-AFC3-7DB4-3FFA-5C1DEC28FE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6F7C046-03FD-7F2D-42C4-CCD1C6206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918D307-B8F7-8C89-5AA2-1382F6964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D9296F2-8A70-83E5-812D-A86F525BD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0320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CA63FD1-306B-D5EB-6954-FB0F89F00C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9BC82AB-3F19-5D53-5A51-C7CDC48156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A17D318-E042-5978-4ACD-0EC2F6A3E8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20C354A-B54A-A526-5770-5A6792647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61D048C-A8C2-B093-9988-FDCE7242F8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C486352-BF9C-E839-219C-469EB5D2E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3569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D0FDD1F-E925-9165-0892-FE50C204C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75321F5-99FF-9E42-F05D-99F29E5D14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76F2D0B-0D05-3308-4702-327B767755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E2D898D-806F-D2D0-80F4-C5ED13371F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A7F0A7B-A805-44A1-0962-229F6DE597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1BD653C-5515-AD82-2417-DAA4F79D2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B6386C8-0853-46C1-3421-A3F3C7D81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286C2A8-5C14-88B2-161B-9AC535390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7685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1A8E69-B743-84B1-19C1-CFCCFC58DD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C8730CD-1623-E209-430C-EBBAB0122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CAC8A36D-9A69-F10D-8270-4E3DF51D8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AF177C7-626C-1029-4442-83CC26CF2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9788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09798B2-B906-C6DC-1036-B69335962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98063C7-5D0C-E27A-5749-F2273B418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9CE6109-7C05-52A0-3309-36AD31CFD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2338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21BF731-ADEF-DB48-C682-32202CFF9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4734820-BA75-CD3E-14C0-DA177D4C73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D7E5CCE-0479-97BC-20FB-11B642671D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42E6D26-F781-62A1-20AF-C2F51F7AA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38704FB-2F0A-2A61-4496-46B5D3FF0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F81167F-305E-6117-57BA-97C1E8030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4706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B85735-FE1E-FE83-9D3C-4E5C932758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A3D1757-4051-2BAA-0AE5-A9B3A8083A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EA96D26-B5C0-EFCC-1557-5892403E4F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2C53BA0-ACFF-FFDB-9938-AA1F44B83E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FAE5227-CF62-0FEC-4CD0-7301D65AF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3415242-278C-D1FF-770A-64D3837AB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1652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493C294-710D-0EA1-5676-6EB0D9A367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5E35406-DC9C-836C-183A-3C55C9B67D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DCEDC94-1741-8882-B745-ADB506FD07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0B22D12-E8B2-4657-9175-183BBE3463A5}" type="datetimeFigureOut">
              <a:rPr lang="es-ES" smtClean="0"/>
              <a:t>13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B331674-321A-21F1-BF6D-90448C2950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8E0E5E-A19D-8B36-8F9C-732BD0F55E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DEA386-62BE-4A66-9104-176337BD3C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0994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Gráfico&#10;&#10;Descripción generada automáticamente">
            <a:extLst>
              <a:ext uri="{FF2B5EF4-FFF2-40B4-BE49-F238E27FC236}">
                <a16:creationId xmlns:a16="http://schemas.microsoft.com/office/drawing/2014/main" id="{C17F649B-CC95-0C08-39E6-C31F24F894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1500" y="1140975"/>
            <a:ext cx="4141754" cy="4111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Imagen 1" descr="Diagrama&#10;&#10;Descripción generada automáticamente con confianza media">
            <a:extLst>
              <a:ext uri="{FF2B5EF4-FFF2-40B4-BE49-F238E27FC236}">
                <a16:creationId xmlns:a16="http://schemas.microsoft.com/office/drawing/2014/main" id="{921E4DD2-E121-CDFD-2159-14707DC990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3720" y="1140975"/>
            <a:ext cx="4141864" cy="4111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Rectangle 4">
            <a:extLst>
              <a:ext uri="{FF2B5EF4-FFF2-40B4-BE49-F238E27FC236}">
                <a16:creationId xmlns:a16="http://schemas.microsoft.com/office/drawing/2014/main" id="{136E1EDF-6565-0722-6F03-D81D7AB5FD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30358" y="5596644"/>
            <a:ext cx="84522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s-E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</a:t>
            </a:r>
            <a:r>
              <a:rPr lang="en-GB" altLang="es-E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GB" altLang="es-E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scriminant analysis of principal components (DAPC) representation of </a:t>
            </a:r>
            <a:r>
              <a:rPr kumimoji="0" lang="en-GB" altLang="es-E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kumimoji="0" lang="en-GB" altLang="es-E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kumimoji="0" lang="en-GB" altLang="es-E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kumimoji="0" lang="en-GB" altLang="es-ES" sz="12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ussatus</a:t>
            </a:r>
            <a:r>
              <a:rPr kumimoji="0" lang="en-GB" altLang="es-E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amples: (A) whole SNP panel (B) geographic divergent outlier panel</a:t>
            </a:r>
            <a:endParaRPr kumimoji="0" lang="en-GB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03568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5</TotalTime>
  <Words>31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e Office</vt:lpstr>
      <vt:lpstr>Presentación de PowerPoint</vt:lpstr>
    </vt:vector>
  </TitlesOfParts>
  <Company>U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TINEZ PORTELA PAULINO</dc:creator>
  <cp:lastModifiedBy>MARTINEZ PORTELA PAULINO</cp:lastModifiedBy>
  <cp:revision>2</cp:revision>
  <dcterms:created xsi:type="dcterms:W3CDTF">2025-02-12T17:11:19Z</dcterms:created>
  <dcterms:modified xsi:type="dcterms:W3CDTF">2025-02-14T13:07:35Z</dcterms:modified>
</cp:coreProperties>
</file>